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EC327E-7FAD-4A2D-A848-C17B79A77D5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708F67-E2FD-45AA-B501-C45444A516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8E7C96-F441-4BD2-B4AB-7E9C8DDD74E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D46946-25C5-4263-8876-9395917592B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32D084-90CF-47FD-8B66-B02BAF2409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CED41C-9501-47D7-A2F1-9AFD64F8FF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96E697-5C5C-4161-8B12-5285CF0D62A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BF8B06-A5FC-4D56-A6EA-7ADAF1A9B0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12F84E-2AEB-4555-A00C-E5A959722B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CF8AC9-7B7A-41A2-9093-CECACF0042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EACC02-32D1-457D-BDDC-1EA44691D6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15F38F-2B5B-4DB7-BAB5-B1808FC2E0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D3158C2-FA86-473F-8289-7E1842473394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"/>
          <p:cNvSpPr/>
          <p:nvPr/>
        </p:nvSpPr>
        <p:spPr>
          <a:xfrm>
            <a:off x="2467800" y="179280"/>
            <a:ext cx="1965240" cy="2764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464 assessed for eligibilit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5"/>
          <p:cNvSpPr/>
          <p:nvPr/>
        </p:nvSpPr>
        <p:spPr>
          <a:xfrm>
            <a:off x="2926080" y="1187280"/>
            <a:ext cx="1023480" cy="2764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58 enroll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7"/>
          <p:cNvSpPr/>
          <p:nvPr/>
        </p:nvSpPr>
        <p:spPr>
          <a:xfrm>
            <a:off x="2207520" y="2638440"/>
            <a:ext cx="2434680" cy="2764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41 eligible for baseline analys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13"/>
          <p:cNvSpPr/>
          <p:nvPr/>
        </p:nvSpPr>
        <p:spPr>
          <a:xfrm>
            <a:off x="4076640" y="611280"/>
            <a:ext cx="2589120" cy="4590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02 ineligible to participat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04 declined to participat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5" name="Group 46"/>
          <p:cNvGrpSpPr/>
          <p:nvPr/>
        </p:nvGrpSpPr>
        <p:grpSpPr>
          <a:xfrm>
            <a:off x="2979360" y="3637080"/>
            <a:ext cx="898920" cy="358560"/>
            <a:chOff x="2979360" y="3637080"/>
            <a:chExt cx="898920" cy="358560"/>
          </a:xfrm>
        </p:grpSpPr>
        <p:cxnSp>
          <p:nvCxnSpPr>
            <p:cNvPr id="46" name="Straight Arrow Connector 23"/>
            <p:cNvCxnSpPr/>
            <p:nvPr/>
          </p:nvCxnSpPr>
          <p:spPr>
            <a:xfrm flipH="1">
              <a:off x="2979360" y="3637080"/>
              <a:ext cx="2160" cy="35892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47" name="Straight Connector 30"/>
            <p:cNvSpPr/>
            <p:nvPr/>
          </p:nvSpPr>
          <p:spPr>
            <a:xfrm>
              <a:off x="2981160" y="3637080"/>
              <a:ext cx="8971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48" name="Straight Arrow Connector 49"/>
            <p:cNvCxnSpPr/>
            <p:nvPr/>
          </p:nvCxnSpPr>
          <p:spPr>
            <a:xfrm flipH="1">
              <a:off x="3876480" y="3637080"/>
              <a:ext cx="2160" cy="35892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arrow" w="med"/>
            </a:ln>
          </p:spPr>
        </p:cxnSp>
      </p:grpSp>
      <p:sp>
        <p:nvSpPr>
          <p:cNvPr id="49" name="Straight Connector 42"/>
          <p:cNvSpPr/>
          <p:nvPr/>
        </p:nvSpPr>
        <p:spPr>
          <a:xfrm>
            <a:off x="3425760" y="2916360"/>
            <a:ext cx="3240" cy="7207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0" name="Straight Arrow Connector 52"/>
          <p:cNvCxnSpPr/>
          <p:nvPr/>
        </p:nvCxnSpPr>
        <p:spPr>
          <a:xfrm>
            <a:off x="3428640" y="826560"/>
            <a:ext cx="500760" cy="252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1" name="Straight Arrow Connector 56"/>
          <p:cNvCxnSpPr/>
          <p:nvPr/>
        </p:nvCxnSpPr>
        <p:spPr>
          <a:xfrm flipH="1">
            <a:off x="3428640" y="468360"/>
            <a:ext cx="2160" cy="65304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52" name="Text Box 13"/>
          <p:cNvSpPr/>
          <p:nvPr/>
        </p:nvSpPr>
        <p:spPr>
          <a:xfrm>
            <a:off x="4098960" y="1476360"/>
            <a:ext cx="2589120" cy="10065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8 non-tuberculous mycobacterial       isolat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3 culture-negativ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5 HIV-infec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 with inadequate sampl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7"/>
          <p:cNvSpPr/>
          <p:nvPr/>
        </p:nvSpPr>
        <p:spPr>
          <a:xfrm>
            <a:off x="377640" y="4079880"/>
            <a:ext cx="2833920" cy="2764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45 African ancestry : baseline analys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7"/>
          <p:cNvSpPr/>
          <p:nvPr/>
        </p:nvSpPr>
        <p:spPr>
          <a:xfrm>
            <a:off x="3504960" y="4068720"/>
            <a:ext cx="2919240" cy="2764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83 Eurasian ancestry: baseline analys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7"/>
          <p:cNvSpPr/>
          <p:nvPr/>
        </p:nvSpPr>
        <p:spPr>
          <a:xfrm>
            <a:off x="404640" y="8218440"/>
            <a:ext cx="1081440" cy="4590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4 ‘fast converters’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7"/>
          <p:cNvSpPr/>
          <p:nvPr/>
        </p:nvSpPr>
        <p:spPr>
          <a:xfrm>
            <a:off x="1671480" y="8218440"/>
            <a:ext cx="1109880" cy="4590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4 ‘slow converters’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7"/>
          <p:cNvSpPr/>
          <p:nvPr/>
        </p:nvSpPr>
        <p:spPr>
          <a:xfrm>
            <a:off x="3932280" y="8218440"/>
            <a:ext cx="1079280" cy="4590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7 ‘fast converters’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7"/>
          <p:cNvSpPr/>
          <p:nvPr/>
        </p:nvSpPr>
        <p:spPr>
          <a:xfrm>
            <a:off x="5199120" y="8218440"/>
            <a:ext cx="1109520" cy="4590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7 ‘slow converters’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13"/>
          <p:cNvSpPr/>
          <p:nvPr/>
        </p:nvSpPr>
        <p:spPr>
          <a:xfrm>
            <a:off x="4098960" y="3062160"/>
            <a:ext cx="2589120" cy="64152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9 East Asian ancestr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3 Latin American ancestr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 mixed ancestr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0" name="Straight Arrow Connector 28"/>
          <p:cNvCxnSpPr/>
          <p:nvPr/>
        </p:nvCxnSpPr>
        <p:spPr>
          <a:xfrm>
            <a:off x="3428640" y="1979640"/>
            <a:ext cx="500760" cy="216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61" name="Straight Arrow Connector 29"/>
          <p:cNvCxnSpPr>
            <a:endCxn id="43" idx="0"/>
          </p:cNvCxnSpPr>
          <p:nvPr/>
        </p:nvCxnSpPr>
        <p:spPr>
          <a:xfrm flipH="1">
            <a:off x="3424680" y="1463400"/>
            <a:ext cx="5760" cy="117540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62" name="Straight Arrow Connector 34"/>
          <p:cNvCxnSpPr/>
          <p:nvPr/>
        </p:nvCxnSpPr>
        <p:spPr>
          <a:xfrm>
            <a:off x="3428640" y="3365640"/>
            <a:ext cx="500760" cy="216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grpSp>
        <p:nvGrpSpPr>
          <p:cNvPr id="63" name="Group 35"/>
          <p:cNvGrpSpPr/>
          <p:nvPr/>
        </p:nvGrpSpPr>
        <p:grpSpPr>
          <a:xfrm>
            <a:off x="909360" y="7885080"/>
            <a:ext cx="1297440" cy="333720"/>
            <a:chOff x="909360" y="7885080"/>
            <a:chExt cx="1297440" cy="333720"/>
          </a:xfrm>
        </p:grpSpPr>
        <p:cxnSp>
          <p:nvCxnSpPr>
            <p:cNvPr id="64" name="Straight Arrow Connector 36"/>
            <p:cNvCxnSpPr/>
            <p:nvPr/>
          </p:nvCxnSpPr>
          <p:spPr>
            <a:xfrm flipH="1">
              <a:off x="909360" y="7885080"/>
              <a:ext cx="3600" cy="3340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65" name="Straight Connector 37"/>
            <p:cNvSpPr/>
            <p:nvPr/>
          </p:nvSpPr>
          <p:spPr>
            <a:xfrm>
              <a:off x="912600" y="7885080"/>
              <a:ext cx="12942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66" name="Straight Arrow Connector 38"/>
            <p:cNvCxnSpPr/>
            <p:nvPr/>
          </p:nvCxnSpPr>
          <p:spPr>
            <a:xfrm flipH="1">
              <a:off x="2203560" y="7885080"/>
              <a:ext cx="3600" cy="3340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arrow" w="med"/>
            </a:ln>
          </p:spPr>
        </p:cxnSp>
      </p:grpSp>
      <p:grpSp>
        <p:nvGrpSpPr>
          <p:cNvPr id="67" name="Group 39"/>
          <p:cNvGrpSpPr/>
          <p:nvPr/>
        </p:nvGrpSpPr>
        <p:grpSpPr>
          <a:xfrm>
            <a:off x="4436640" y="7885080"/>
            <a:ext cx="1296000" cy="333720"/>
            <a:chOff x="4436640" y="7885080"/>
            <a:chExt cx="1296000" cy="333720"/>
          </a:xfrm>
        </p:grpSpPr>
        <p:cxnSp>
          <p:nvCxnSpPr>
            <p:cNvPr id="68" name="Straight Arrow Connector 40"/>
            <p:cNvCxnSpPr/>
            <p:nvPr/>
          </p:nvCxnSpPr>
          <p:spPr>
            <a:xfrm flipH="1">
              <a:off x="4436640" y="7885080"/>
              <a:ext cx="3600" cy="3340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69" name="Straight Connector 41"/>
            <p:cNvSpPr/>
            <p:nvPr/>
          </p:nvSpPr>
          <p:spPr>
            <a:xfrm>
              <a:off x="4439880" y="7885080"/>
              <a:ext cx="12927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70" name="Straight Arrow Connector 43"/>
            <p:cNvCxnSpPr/>
            <p:nvPr/>
          </p:nvCxnSpPr>
          <p:spPr>
            <a:xfrm flipH="1">
              <a:off x="5729400" y="7885080"/>
              <a:ext cx="3600" cy="3340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arrow" w="med"/>
            </a:ln>
          </p:spPr>
        </p:cxnSp>
      </p:grpSp>
      <p:sp>
        <p:nvSpPr>
          <p:cNvPr id="71" name="Text Box 7"/>
          <p:cNvSpPr/>
          <p:nvPr/>
        </p:nvSpPr>
        <p:spPr>
          <a:xfrm>
            <a:off x="189000" y="4643280"/>
            <a:ext cx="2592360" cy="173664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15 excluded from 8-week analyses: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- 3 not randomis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buClr>
                <a:srgbClr val="00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 with rifampicin-resistant isolat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buClr>
                <a:srgbClr val="00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1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M. Africanum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isolat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buClr>
                <a:srgbClr val="00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6 interrupted / non-compliant with medication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buClr>
                <a:srgbClr val="00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 took oral corticosteroid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buClr>
                <a:srgbClr val="00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3 took second-line therap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7"/>
          <p:cNvSpPr/>
          <p:nvPr/>
        </p:nvSpPr>
        <p:spPr>
          <a:xfrm>
            <a:off x="4098960" y="4643280"/>
            <a:ext cx="2592360" cy="173664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28 excluded from 8-week analyses: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- 7 not randomis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buClr>
                <a:srgbClr val="00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 rifampicin-resistant isolat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buClr>
                <a:srgbClr val="00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0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M. Africanum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isolat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buClr>
                <a:srgbClr val="00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16 interrupted / non-compliant with medic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buClr>
                <a:srgbClr val="00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5 took oral corticosteroid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buClr>
                <a:srgbClr val="00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 took second-line therap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7"/>
          <p:cNvSpPr/>
          <p:nvPr/>
        </p:nvSpPr>
        <p:spPr>
          <a:xfrm>
            <a:off x="335160" y="6659640"/>
            <a:ext cx="2713680" cy="2764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30 African ancestry: 8-week analys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7"/>
          <p:cNvSpPr/>
          <p:nvPr/>
        </p:nvSpPr>
        <p:spPr>
          <a:xfrm>
            <a:off x="3506760" y="6659640"/>
            <a:ext cx="2841480" cy="2764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55 Eurasian ancestry: 8-week analys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5" name="Straight Arrow Connector 47"/>
          <p:cNvCxnSpPr/>
          <p:nvPr/>
        </p:nvCxnSpPr>
        <p:spPr>
          <a:xfrm>
            <a:off x="2997000" y="4356000"/>
            <a:ext cx="1080" cy="223272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6" name="Straight Arrow Connector 50"/>
          <p:cNvCxnSpPr/>
          <p:nvPr/>
        </p:nvCxnSpPr>
        <p:spPr>
          <a:xfrm>
            <a:off x="3860280" y="4356000"/>
            <a:ext cx="1080" cy="223272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77" name="Straight Connector 60"/>
          <p:cNvSpPr/>
          <p:nvPr/>
        </p:nvSpPr>
        <p:spPr>
          <a:xfrm>
            <a:off x="1628640" y="6937200"/>
            <a:ext cx="0" cy="9478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8" name="Straight Arrow Connector 61"/>
          <p:cNvCxnSpPr/>
          <p:nvPr/>
        </p:nvCxnSpPr>
        <p:spPr>
          <a:xfrm>
            <a:off x="3860640" y="5724000"/>
            <a:ext cx="21672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9" name="Straight Arrow Connector 65"/>
          <p:cNvCxnSpPr/>
          <p:nvPr/>
        </p:nvCxnSpPr>
        <p:spPr>
          <a:xfrm flipH="1">
            <a:off x="2781000" y="5724000"/>
            <a:ext cx="21672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80" name="TextBox 44"/>
          <p:cNvSpPr/>
          <p:nvPr/>
        </p:nvSpPr>
        <p:spPr>
          <a:xfrm>
            <a:off x="1285200" y="8748720"/>
            <a:ext cx="4217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some participants were excluded for more than one reas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7"/>
          <p:cNvSpPr/>
          <p:nvPr/>
        </p:nvSpPr>
        <p:spPr>
          <a:xfrm>
            <a:off x="187200" y="7093080"/>
            <a:ext cx="1225800" cy="64152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 miss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follow-up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sputum cultur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7"/>
          <p:cNvSpPr/>
          <p:nvPr/>
        </p:nvSpPr>
        <p:spPr>
          <a:xfrm>
            <a:off x="5300640" y="7094520"/>
            <a:ext cx="1224000" cy="64152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1 miss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follow-up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sputum cultur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3" name="Straight Arrow Connector 51"/>
          <p:cNvCxnSpPr/>
          <p:nvPr/>
        </p:nvCxnSpPr>
        <p:spPr>
          <a:xfrm flipH="1">
            <a:off x="1412280" y="7380000"/>
            <a:ext cx="21636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84" name="Straight Arrow Connector 53"/>
          <p:cNvCxnSpPr/>
          <p:nvPr/>
        </p:nvCxnSpPr>
        <p:spPr>
          <a:xfrm>
            <a:off x="5084640" y="7380000"/>
            <a:ext cx="21672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85" name="Straight Connector 54"/>
          <p:cNvSpPr/>
          <p:nvPr/>
        </p:nvSpPr>
        <p:spPr>
          <a:xfrm>
            <a:off x="5084640" y="6937200"/>
            <a:ext cx="1800" cy="9478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16T13:45:23Z</dcterms:created>
  <dc:creator>amartineau</dc:creator>
  <dc:description/>
  <dc:language>en-US</dc:language>
  <cp:lastModifiedBy>AMartineau</cp:lastModifiedBy>
  <dcterms:modified xsi:type="dcterms:W3CDTF">2013-05-15T08:02:58Z</dcterms:modified>
  <cp:revision>232</cp:revision>
  <dc:subject/>
  <dc:title>Slide 1</dc:title>
</cp:coreProperties>
</file>